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60" r:id="rId4"/>
    <p:sldId id="258" r:id="rId5"/>
    <p:sldId id="259" r:id="rId6"/>
    <p:sldId id="256" r:id="rId7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426" y="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4200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2765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0488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9355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412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24385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7661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3718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782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2144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9277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3A132-ED76-4947-9313-4B4C4495F184}" type="datetimeFigureOut">
              <a:rPr lang="it-IT" smtClean="0"/>
              <a:pPr/>
              <a:t>20/0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9C384E-13BD-47F1-9243-D77464AA1F6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2021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5408566"/>
              </p:ext>
            </p:extLst>
          </p:nvPr>
        </p:nvGraphicFramePr>
        <p:xfrm>
          <a:off x="467544" y="692696"/>
          <a:ext cx="8109411" cy="467936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0922"/>
                <a:gridCol w="689300"/>
                <a:gridCol w="694166"/>
                <a:gridCol w="580634"/>
                <a:gridCol w="575768"/>
                <a:gridCol w="689300"/>
                <a:gridCol w="694166"/>
                <a:gridCol w="488186"/>
                <a:gridCol w="609827"/>
                <a:gridCol w="606584"/>
                <a:gridCol w="603340"/>
                <a:gridCol w="601718"/>
                <a:gridCol w="585500"/>
              </a:tblGrid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12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TUMOR PD-L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TIL PD-L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TUMOR &amp; TIL PD-L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ge 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Low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High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 value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8140" algn="ctr"/>
                        </a:tabLst>
                      </a:pPr>
                      <a:r>
                        <a:rPr lang="en-US" sz="600">
                          <a:effectLst/>
                        </a:rPr>
                        <a:t>R Pearson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8140" algn="ctr"/>
                        </a:tabLst>
                      </a:pPr>
                      <a:r>
                        <a:rPr lang="en-US" sz="600">
                          <a:effectLst/>
                        </a:rPr>
                        <a:t>Low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8140" algn="ctr"/>
                        </a:tabLst>
                      </a:pPr>
                      <a:r>
                        <a:rPr lang="en-US" sz="600">
                          <a:effectLst/>
                        </a:rPr>
                        <a:t>High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8140" algn="ctr"/>
                        </a:tabLst>
                      </a:pPr>
                      <a:r>
                        <a:rPr lang="en-US" sz="600">
                          <a:effectLst/>
                        </a:rPr>
                        <a:t>P value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8140" algn="ctr"/>
                        </a:tabLst>
                      </a:pPr>
                      <a:r>
                        <a:rPr lang="en-US" sz="600">
                          <a:effectLst/>
                        </a:rPr>
                        <a:t>R Pearson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8140" algn="ctr"/>
                        </a:tabLst>
                      </a:pPr>
                      <a:r>
                        <a:rPr lang="en-US" sz="600">
                          <a:effectLst/>
                        </a:rPr>
                        <a:t>Low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8140" algn="ctr"/>
                        </a:tabLst>
                      </a:pPr>
                      <a:r>
                        <a:rPr lang="en-US" sz="600">
                          <a:effectLst/>
                        </a:rPr>
                        <a:t>High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8140" algn="ctr"/>
                        </a:tabLst>
                      </a:pPr>
                      <a:r>
                        <a:rPr lang="en-US" sz="600">
                          <a:effectLst/>
                        </a:rPr>
                        <a:t>P value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8140" algn="ctr"/>
                        </a:tabLst>
                      </a:pPr>
                      <a:r>
                        <a:rPr lang="en-US" sz="600">
                          <a:effectLst/>
                        </a:rPr>
                        <a:t>R Pearson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</a:tr>
              <a:tr h="3047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&lt;40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  <a:sym typeface="Symbol"/>
                        </a:rPr>
                        <a:t></a:t>
                      </a:r>
                      <a:r>
                        <a:rPr lang="en-US" sz="600">
                          <a:effectLst/>
                        </a:rPr>
                        <a:t>40</a:t>
                      </a:r>
                      <a:r>
                        <a:rPr lang="it-IT" sz="600">
                          <a:effectLst/>
                          <a:sym typeface="Symbol"/>
                        </a:rPr>
                        <a:t></a:t>
                      </a:r>
                      <a:r>
                        <a:rPr lang="en-US" sz="600">
                          <a:effectLst/>
                        </a:rPr>
                        <a:t>60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&gt;60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5 (6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56 (58,3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69 (71,9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0 (4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0 (41,7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7 (28,1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12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 0,11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7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3 (52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8 (60,9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 (3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0 (47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8 (39,1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46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012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7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3 (68,3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3 (73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 (3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0 (31,7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2 (26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850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042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Histotype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Ductal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on Ductal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120 (62,9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22 (78,6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1 (37,1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 (21,4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10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 0,110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6 (59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 (2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5 (40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 (7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57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57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9 (71,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 (5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1 (28,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 (5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192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120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</a:tr>
              <a:tr h="15765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Menopausal state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re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ost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41 (52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99 (71,2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7 (47,4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0 (28,8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06*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187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4 (51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4 (61,1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3 (49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8 (38,9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27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09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0 (63,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3 (74,6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7 (44,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8 (25,4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20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116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6253" marR="66253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Tumor size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3047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  <a:sym typeface="Symbol"/>
                        </a:rPr>
                        <a:t></a:t>
                      </a:r>
                      <a:r>
                        <a:rPr lang="it-IT" sz="600">
                          <a:effectLst/>
                        </a:rPr>
                        <a:t>2 cm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&gt;2</a:t>
                      </a:r>
                      <a:r>
                        <a:rPr lang="it-IT" sz="600">
                          <a:effectLst/>
                          <a:sym typeface="Symbol"/>
                        </a:rPr>
                        <a:t></a:t>
                      </a:r>
                      <a:r>
                        <a:rPr lang="it-IT" sz="600">
                          <a:effectLst/>
                        </a:rPr>
                        <a:t>5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&gt;5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3 (64,9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0 (63,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3 (72,2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4 (35,1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5 (36,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 (27,8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76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01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6 (56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6 (63,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 (4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0 (43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1 (46,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 (6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36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2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1 (67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3 (75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 (6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5 (32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4 (24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 (4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49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015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LNM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marL="6858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Negative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Positive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1 (60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8 (76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0 (39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8 (23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26*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16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9 (56,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6 (51,6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2 (43,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5 (48,4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64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5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6 (7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1 (67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4 (3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0 (32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68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45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Metastases 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Negative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Positive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82 (66,7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1 (81,6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1 (33,3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18,4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7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13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6 (5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9 (64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4 (4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 (35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414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102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7 (7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1 (78,6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3 (2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 (21,4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727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044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Grade 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3047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G1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G2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G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 (10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5 (68,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16 (62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 (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31,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9 (37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494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6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 (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63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6 (55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 (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 (36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5 (44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60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4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 (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63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0 (7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 (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 (36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0 (3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664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04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Ki-67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Low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High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1 (83,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07 (61,1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 (16,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8 (38,9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09*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180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1 (78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5 (54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 (21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6 (45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87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15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1 (78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0 (7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 (21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0 (30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50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62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BMI 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&lt;30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  <a:sym typeface="Symbol"/>
                        </a:rPr>
                        <a:t></a:t>
                      </a:r>
                      <a:r>
                        <a:rPr lang="it-IT" sz="600">
                          <a:effectLst/>
                        </a:rPr>
                        <a:t>30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8 (73,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6 (74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7 (26,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9 (25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962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005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3 (5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8 (61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2 (4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 (38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575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09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8 (72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1 (84,6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2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 (15,4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386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14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Diabetes 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No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Yes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2 (82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3 (59,1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9 (17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9 (40,9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34*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24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5 (45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 (83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8 (54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 (16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8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27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3 (69,7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 (83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0 (30,3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 (16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495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10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Glicemya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&lt;110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&gt;110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43 (82,7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0 (58,8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9 (17,3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41,2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43*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244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5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87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50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 (12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79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375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1 (78,6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7 (87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 (21,4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 (12,5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60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-0,11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Status 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Alive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Dead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6 (66,7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0 (66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33 (32,3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 (32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00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2 (59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9 (52,9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5 (40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8 (47,1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65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61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8 (75,7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1 (64,7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9 (24,3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6 (35,3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40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114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10158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Relapse 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  <a:tr h="20317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No</a:t>
                      </a:r>
                      <a:endParaRPr lang="it-IT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Yes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47 (61,8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42 (84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29 (38,2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53695" algn="l"/>
                          <a:tab pos="422910" algn="ctr"/>
                        </a:tabLst>
                      </a:pPr>
                      <a:r>
                        <a:rPr lang="en-US" sz="600">
                          <a:effectLst/>
                        </a:rPr>
                        <a:t>8 (16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0,008*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-0,238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2 (64,7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 (29,4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2 (35,3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2 (70,6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017</a:t>
                      </a:r>
                      <a:r>
                        <a:rPr lang="en-US" sz="600">
                          <a:effectLst/>
                        </a:rPr>
                        <a:t>*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333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26 (76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12 (70,6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8 (23,5%)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5 (29,4%)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>
                          <a:effectLst/>
                        </a:rPr>
                        <a:t>0,650</a:t>
                      </a:r>
                      <a:endParaRPr lang="it-IT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600" dirty="0">
                          <a:effectLst/>
                        </a:rPr>
                        <a:t>0,064</a:t>
                      </a:r>
                      <a:endParaRPr lang="it-IT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42942" marR="42942" marT="0" marB="0"/>
                </a:tc>
              </a:tr>
            </a:tbl>
          </a:graphicData>
        </a:graphic>
      </p:graphicFrame>
      <p:sp>
        <p:nvSpPr>
          <p:cNvPr id="5" name="Rettangolo 4"/>
          <p:cNvSpPr/>
          <p:nvPr/>
        </p:nvSpPr>
        <p:spPr>
          <a:xfrm>
            <a:off x="2123728" y="5661248"/>
            <a:ext cx="4572000" cy="5770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50" b="1" dirty="0"/>
              <a:t>Supplementary Table 1. </a:t>
            </a:r>
            <a:r>
              <a:rPr lang="en-US" sz="1050" dirty="0"/>
              <a:t>Clinical pathological features of TNBC samples and statistical association with tumor and TIL PD-L1 expression. LNM=Lymph Node Metastasis.</a:t>
            </a:r>
            <a:endParaRPr lang="it-IT" sz="1050" dirty="0"/>
          </a:p>
        </p:txBody>
      </p:sp>
    </p:spTree>
    <p:extLst>
      <p:ext uri="{BB962C8B-B14F-4D97-AF65-F5344CB8AC3E}">
        <p14:creationId xmlns:p14="http://schemas.microsoft.com/office/powerpoint/2010/main" val="1757656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2" y="2060848"/>
            <a:ext cx="3475037" cy="1493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CasellaDiTesto 3"/>
          <p:cNvSpPr txBox="1"/>
          <p:nvPr/>
        </p:nvSpPr>
        <p:spPr>
          <a:xfrm>
            <a:off x="3275856" y="4221088"/>
            <a:ext cx="48965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err="1" smtClean="0"/>
              <a:t>Supplementary</a:t>
            </a:r>
            <a:r>
              <a:rPr lang="it-IT" sz="1000" b="1" dirty="0" smtClean="0"/>
              <a:t> Figure 1: </a:t>
            </a:r>
            <a:r>
              <a:rPr lang="en-US" sz="1000" dirty="0"/>
              <a:t>TIL</a:t>
            </a:r>
            <a:r>
              <a:rPr lang="en-US" sz="1000" b="1" dirty="0"/>
              <a:t> </a:t>
            </a:r>
            <a:r>
              <a:rPr lang="en-US" sz="1000" dirty="0"/>
              <a:t>PD-L1+  patients Kaplan-Meier curves:  (a) Disease Free Survival (DFS) (p=0,391); (b) Overall Survival (OS) (p=0,630).</a:t>
            </a:r>
            <a:endParaRPr lang="it-IT" sz="1000" b="1" dirty="0"/>
          </a:p>
        </p:txBody>
      </p:sp>
    </p:spTree>
    <p:extLst>
      <p:ext uri="{BB962C8B-B14F-4D97-AF65-F5344CB8AC3E}">
        <p14:creationId xmlns:p14="http://schemas.microsoft.com/office/powerpoint/2010/main" val="5309503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3525" y="2676525"/>
            <a:ext cx="3535363" cy="1503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CasellaDiTesto 4"/>
          <p:cNvSpPr txBox="1"/>
          <p:nvPr/>
        </p:nvSpPr>
        <p:spPr>
          <a:xfrm>
            <a:off x="2627784" y="4621198"/>
            <a:ext cx="489654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err="1" smtClean="0"/>
              <a:t>Supplementary</a:t>
            </a:r>
            <a:r>
              <a:rPr lang="it-IT" sz="1000" b="1" dirty="0" smtClean="0"/>
              <a:t> </a:t>
            </a:r>
            <a:r>
              <a:rPr lang="it-IT" sz="1000" b="1" smtClean="0"/>
              <a:t>Figure </a:t>
            </a:r>
            <a:r>
              <a:rPr lang="it-IT" sz="1000" b="1" smtClean="0"/>
              <a:t>2: </a:t>
            </a:r>
            <a:r>
              <a:rPr lang="en-US" sz="1000" dirty="0" smtClean="0"/>
              <a:t> </a:t>
            </a:r>
            <a:r>
              <a:rPr lang="en-US" sz="1000" dirty="0"/>
              <a:t>Tumor/TIL</a:t>
            </a:r>
            <a:r>
              <a:rPr lang="en-US" sz="1000" b="1" dirty="0"/>
              <a:t> </a:t>
            </a:r>
            <a:r>
              <a:rPr lang="en-US" sz="1000" dirty="0"/>
              <a:t>PD-L1+ TNBC patients Kaplan-Meier curves:  (a) Disease Free Survival (DFS) (p=417); (b) Overall Survival (OS) (p=615).</a:t>
            </a:r>
            <a:endParaRPr lang="it-IT" sz="1000" dirty="0"/>
          </a:p>
          <a:p>
            <a:endParaRPr lang="it-IT" sz="1000" b="1" dirty="0"/>
          </a:p>
        </p:txBody>
      </p:sp>
    </p:spTree>
    <p:extLst>
      <p:ext uri="{BB962C8B-B14F-4D97-AF65-F5344CB8AC3E}">
        <p14:creationId xmlns:p14="http://schemas.microsoft.com/office/powerpoint/2010/main" val="38596648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operatori\Desktop\lavori in process\VPD-L1 and triple negative\foto nuove\P1260019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5" b="5128"/>
          <a:stretch>
            <a:fillRect/>
          </a:stretch>
        </p:blipFill>
        <p:spPr bwMode="auto">
          <a:xfrm>
            <a:off x="899592" y="188640"/>
            <a:ext cx="3637880" cy="2664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operatori\Desktop\lavori in process\VPD-L1 and triple negative\foto nuove\P1260016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3" b="7692"/>
          <a:stretch>
            <a:fillRect/>
          </a:stretch>
        </p:blipFill>
        <p:spPr bwMode="auto">
          <a:xfrm>
            <a:off x="899592" y="3501008"/>
            <a:ext cx="3672408" cy="2592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operatori\Desktop\lavori in process\VPD-L1 and triple negative\foto nuove\P126002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128"/>
          <a:stretch>
            <a:fillRect/>
          </a:stretch>
        </p:blipFill>
        <p:spPr bwMode="auto">
          <a:xfrm>
            <a:off x="4860032" y="188640"/>
            <a:ext cx="3744416" cy="2664296"/>
          </a:xfrm>
          <a:prstGeom prst="rect">
            <a:avLst/>
          </a:prstGeom>
          <a:noFill/>
          <a:ln w="19050">
            <a:solidFill>
              <a:schemeClr val="accent1">
                <a:shade val="95000"/>
                <a:satMod val="10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operatori\Desktop\lavori in process\VPD-L1 and triple negative\foto nuove\P1260018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601"/>
          <a:stretch>
            <a:fillRect/>
          </a:stretch>
        </p:blipFill>
        <p:spPr bwMode="auto">
          <a:xfrm>
            <a:off x="4860032" y="3501008"/>
            <a:ext cx="3700669" cy="2592288"/>
          </a:xfrm>
          <a:prstGeom prst="rect">
            <a:avLst/>
          </a:prstGeom>
          <a:noFill/>
          <a:ln w="19050">
            <a:solidFill>
              <a:schemeClr val="accent1">
                <a:shade val="95000"/>
                <a:satMod val="10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CasellaDiTesto 7"/>
          <p:cNvSpPr txBox="1"/>
          <p:nvPr/>
        </p:nvSpPr>
        <p:spPr>
          <a:xfrm>
            <a:off x="296796" y="54868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(A)</a:t>
            </a:r>
            <a:endParaRPr lang="it-IT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304812" y="377974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(B)</a:t>
            </a:r>
            <a:endParaRPr lang="it-IT" dirty="0"/>
          </a:p>
        </p:txBody>
      </p:sp>
      <p:sp>
        <p:nvSpPr>
          <p:cNvPr id="3" name="CasellaDiTesto 2"/>
          <p:cNvSpPr txBox="1"/>
          <p:nvPr/>
        </p:nvSpPr>
        <p:spPr>
          <a:xfrm>
            <a:off x="830016" y="6309320"/>
            <a:ext cx="7846439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b="1" dirty="0" err="1" smtClean="0"/>
              <a:t>Supplementary</a:t>
            </a:r>
            <a:r>
              <a:rPr lang="it-IT" b="1" dirty="0" smtClean="0"/>
              <a:t> </a:t>
            </a:r>
            <a:r>
              <a:rPr lang="it-IT" sz="1050" b="1" dirty="0" smtClean="0"/>
              <a:t>Figure</a:t>
            </a:r>
            <a:r>
              <a:rPr lang="it-IT" b="1" dirty="0" smtClean="0"/>
              <a:t> </a:t>
            </a:r>
            <a:r>
              <a:rPr lang="it-IT" sz="1050" b="1" dirty="0" smtClean="0"/>
              <a:t>3: </a:t>
            </a:r>
            <a:r>
              <a:rPr lang="en-US" sz="1050" dirty="0"/>
              <a:t>PD-L1 staining in adjacent TMA cores from the same sample (10X) (A-B)   with details  of intra-tumor cells (20X) (A)  and tumor invasive front (20X) (B).</a:t>
            </a:r>
            <a:endParaRPr lang="it-IT" sz="1050" dirty="0"/>
          </a:p>
          <a:p>
            <a:endParaRPr lang="it-IT" sz="1050" b="1" dirty="0"/>
          </a:p>
        </p:txBody>
      </p:sp>
      <p:cxnSp>
        <p:nvCxnSpPr>
          <p:cNvPr id="13" name="Connettore 1 12"/>
          <p:cNvCxnSpPr/>
          <p:nvPr/>
        </p:nvCxnSpPr>
        <p:spPr>
          <a:xfrm>
            <a:off x="2915816" y="2132856"/>
            <a:ext cx="1944216" cy="72008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ttore 1 17"/>
          <p:cNvCxnSpPr/>
          <p:nvPr/>
        </p:nvCxnSpPr>
        <p:spPr>
          <a:xfrm flipV="1">
            <a:off x="2843808" y="188640"/>
            <a:ext cx="2016224" cy="1008112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1 33"/>
          <p:cNvCxnSpPr/>
          <p:nvPr/>
        </p:nvCxnSpPr>
        <p:spPr>
          <a:xfrm>
            <a:off x="2123728" y="5949280"/>
            <a:ext cx="2736304" cy="14401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ttore 1 34"/>
          <p:cNvCxnSpPr/>
          <p:nvPr/>
        </p:nvCxnSpPr>
        <p:spPr>
          <a:xfrm flipV="1">
            <a:off x="2051720" y="3501008"/>
            <a:ext cx="2808312" cy="1728192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122129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395536" y="4885710"/>
            <a:ext cx="708238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50" b="1" dirty="0" err="1" smtClean="0"/>
              <a:t>Supplementary</a:t>
            </a:r>
            <a:r>
              <a:rPr lang="it-IT" sz="1050" b="1" dirty="0" smtClean="0"/>
              <a:t> Figure 4: </a:t>
            </a:r>
            <a:r>
              <a:rPr lang="en-US" sz="1050" dirty="0" smtClean="0"/>
              <a:t>Immunostaining of PD-L1 (A), CD3 (B) and CD20(C) proteins on the same sample (magnification 40X).</a:t>
            </a:r>
            <a:endParaRPr lang="it-IT" sz="1050" dirty="0"/>
          </a:p>
          <a:p>
            <a:r>
              <a:rPr lang="it-IT" sz="1050" b="1" dirty="0" smtClean="0"/>
              <a:t> </a:t>
            </a:r>
            <a:endParaRPr lang="it-IT" sz="1050" b="1" dirty="0"/>
          </a:p>
        </p:txBody>
      </p:sp>
      <p:pic>
        <p:nvPicPr>
          <p:cNvPr id="3" name="Immagine 2" descr="pannello caratterizzazione TILs senza lettere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2132856"/>
            <a:ext cx="9144000" cy="2273684"/>
          </a:xfrm>
          <a:prstGeom prst="rect">
            <a:avLst/>
          </a:prstGeom>
        </p:spPr>
      </p:pic>
      <p:sp>
        <p:nvSpPr>
          <p:cNvPr id="4" name="CasellaDiTesto 3"/>
          <p:cNvSpPr txBox="1"/>
          <p:nvPr/>
        </p:nvSpPr>
        <p:spPr>
          <a:xfrm>
            <a:off x="2555776" y="2132856"/>
            <a:ext cx="428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smtClean="0"/>
              <a:t>(A)</a:t>
            </a:r>
            <a:endParaRPr lang="it-IT" sz="1600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5652120" y="2132856"/>
            <a:ext cx="4219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smtClean="0"/>
              <a:t>(B)</a:t>
            </a:r>
            <a:endParaRPr lang="it-IT" sz="1600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8676456" y="2132856"/>
            <a:ext cx="4187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smtClean="0"/>
              <a:t>(C)</a:t>
            </a:r>
            <a:endParaRPr lang="it-IT" sz="1600" dirty="0"/>
          </a:p>
        </p:txBody>
      </p:sp>
    </p:spTree>
    <p:extLst>
      <p:ext uri="{BB962C8B-B14F-4D97-AF65-F5344CB8AC3E}">
        <p14:creationId xmlns:p14="http://schemas.microsoft.com/office/powerpoint/2010/main" val="7041536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operatori\Desktop\lavori in process\VPD-L1 and triple negative\foto nuove\P126002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306"/>
          <a:stretch>
            <a:fillRect/>
          </a:stretch>
        </p:blipFill>
        <p:spPr bwMode="auto">
          <a:xfrm>
            <a:off x="179512" y="1916832"/>
            <a:ext cx="2664296" cy="18722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operatori\Desktop\lavori in process\VPD-L1 and triple negative\foto nuove\P1260022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306"/>
          <a:stretch>
            <a:fillRect/>
          </a:stretch>
        </p:blipFill>
        <p:spPr bwMode="auto">
          <a:xfrm>
            <a:off x="3059832" y="1916832"/>
            <a:ext cx="2664296" cy="18722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operatori\Desktop\lavori in process\VPD-L1 and triple negative\foto nuove\P1260023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339"/>
          <a:stretch>
            <a:fillRect/>
          </a:stretch>
        </p:blipFill>
        <p:spPr bwMode="auto">
          <a:xfrm>
            <a:off x="5940152" y="1927193"/>
            <a:ext cx="2650481" cy="18618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CasellaDiTesto 3"/>
          <p:cNvSpPr txBox="1"/>
          <p:nvPr/>
        </p:nvSpPr>
        <p:spPr>
          <a:xfrm>
            <a:off x="183238" y="1916832"/>
            <a:ext cx="428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smtClean="0"/>
              <a:t>(A)</a:t>
            </a:r>
            <a:endParaRPr lang="it-IT" sz="1600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3059832" y="1916832"/>
            <a:ext cx="4219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smtClean="0"/>
              <a:t>(B)</a:t>
            </a:r>
            <a:endParaRPr lang="it-IT" sz="1600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5940152" y="1916832"/>
            <a:ext cx="4187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smtClean="0"/>
              <a:t>(C)</a:t>
            </a:r>
            <a:endParaRPr lang="it-IT" sz="1600" dirty="0"/>
          </a:p>
        </p:txBody>
      </p:sp>
      <p:cxnSp>
        <p:nvCxnSpPr>
          <p:cNvPr id="6" name="Connettore 2 5"/>
          <p:cNvCxnSpPr/>
          <p:nvPr/>
        </p:nvCxnSpPr>
        <p:spPr>
          <a:xfrm>
            <a:off x="1511660" y="2564904"/>
            <a:ext cx="1548172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2 11"/>
          <p:cNvCxnSpPr/>
          <p:nvPr/>
        </p:nvCxnSpPr>
        <p:spPr>
          <a:xfrm>
            <a:off x="4067944" y="2780928"/>
            <a:ext cx="187220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asellaDiTesto 1"/>
          <p:cNvSpPr txBox="1"/>
          <p:nvPr/>
        </p:nvSpPr>
        <p:spPr>
          <a:xfrm>
            <a:off x="539552" y="4275228"/>
            <a:ext cx="842570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50" b="1" dirty="0" err="1" smtClean="0"/>
              <a:t>Supplementary</a:t>
            </a:r>
            <a:r>
              <a:rPr lang="it-IT" sz="1050" b="1" dirty="0" smtClean="0"/>
              <a:t> Figure 5:</a:t>
            </a:r>
            <a:r>
              <a:rPr lang="en-US" sz="1050" dirty="0"/>
              <a:t>Cytoplasmic and cell membrane staining of PD-L1 protein: (A) magnification 10X; (B) magnification 20X; (C) magnification 40X.</a:t>
            </a:r>
            <a:endParaRPr lang="it-IT" sz="1050" dirty="0"/>
          </a:p>
          <a:p>
            <a:r>
              <a:rPr lang="it-IT" sz="1050" b="1" dirty="0" smtClean="0"/>
              <a:t> </a:t>
            </a:r>
            <a:endParaRPr lang="it-IT" sz="1050" b="1" dirty="0"/>
          </a:p>
        </p:txBody>
      </p:sp>
    </p:spTree>
    <p:extLst>
      <p:ext uri="{BB962C8B-B14F-4D97-AF65-F5344CB8AC3E}">
        <p14:creationId xmlns:p14="http://schemas.microsoft.com/office/powerpoint/2010/main" val="281482139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3</TotalTime>
  <Words>1081</Words>
  <Application>Microsoft Office PowerPoint</Application>
  <PresentationFormat>On-screen Show (4:3)</PresentationFormat>
  <Paragraphs>49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Symbol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lidata S.p.A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operatori</dc:creator>
  <cp:lastModifiedBy>MDPI</cp:lastModifiedBy>
  <cp:revision>10</cp:revision>
  <dcterms:created xsi:type="dcterms:W3CDTF">2017-01-27T09:15:46Z</dcterms:created>
  <dcterms:modified xsi:type="dcterms:W3CDTF">2017-02-20T08:02:35Z</dcterms:modified>
</cp:coreProperties>
</file>